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4" d="100"/>
          <a:sy n="54" d="100"/>
        </p:scale>
        <p:origin x="24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DF6D05-0ABE-4776-8A3B-06B1FDA69686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08744F-E6FF-42B4-9565-3348615F6D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5797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08744F-E6FF-42B4-9565-3348615F6DF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231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118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0204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015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868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885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1263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454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379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644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524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188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2525C-8BE3-4365-9DA7-A0170A9CDA7B}" type="datetimeFigureOut">
              <a:rPr lang="zh-CN" altLang="en-US" smtClean="0"/>
              <a:t>2026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63951-3103-499E-9263-747B521290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856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32BDBD2-5408-8BD1-804E-25547213C8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84320" y="1503966"/>
            <a:ext cx="2160000" cy="364610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EA00983-3E4E-A88B-A8A5-1B9696032A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49139" y="1601251"/>
            <a:ext cx="1981895" cy="348967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0E88B75-1254-2467-FEFE-6046E117152F}"/>
              </a:ext>
            </a:extLst>
          </p:cNvPr>
          <p:cNvSpPr txBox="1"/>
          <p:nvPr/>
        </p:nvSpPr>
        <p:spPr>
          <a:xfrm>
            <a:off x="1757357" y="78581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NGE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358CD19-2076-A0BA-88B9-05C7EB942C21}"/>
              </a:ext>
            </a:extLst>
          </p:cNvPr>
          <p:cNvSpPr txBox="1"/>
          <p:nvPr/>
        </p:nvSpPr>
        <p:spPr>
          <a:xfrm>
            <a:off x="4418983" y="785813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HIE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75A5957-3BD4-0074-C496-B58AB7A37467}"/>
              </a:ext>
            </a:extLst>
          </p:cNvPr>
          <p:cNvSpPr txBox="1"/>
          <p:nvPr/>
        </p:nvSpPr>
        <p:spPr>
          <a:xfrm>
            <a:off x="0" y="0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03B21C3-F302-2B2A-6376-EE2F94DE1854}"/>
              </a:ext>
            </a:extLst>
          </p:cNvPr>
          <p:cNvSpPr txBox="1"/>
          <p:nvPr/>
        </p:nvSpPr>
        <p:spPr>
          <a:xfrm>
            <a:off x="400052" y="5313689"/>
            <a:ext cx="6086475" cy="30868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zh-CN" sz="1100" b="1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1 Fig</a:t>
            </a:r>
            <a:r>
              <a:rPr lang="en-US" altLang="zh-CN" sz="1100" b="1" kern="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100" b="1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Quantitative analysis of mitochondria with </a:t>
            </a:r>
            <a:r>
              <a:rPr lang="en-US" altLang="zh-CN" sz="1100" b="1" kern="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erroptotic</a:t>
            </a:r>
            <a:r>
              <a:rPr lang="en-US" altLang="zh-CN" sz="1100" b="1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morphology under transmission electron microscopy (TEM). </a:t>
            </a:r>
            <a:endParaRPr lang="zh-CN" altLang="zh-CN" sz="11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RNAs for negative control or HILPDA were transfected into NGEC and HIEC under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ormoxic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conditions for 24 h, after which the cells were exposed to hypoxia (1% O</a:t>
            </a:r>
            <a:r>
              <a:rPr lang="en-US" altLang="zh-CN" sz="11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 for 48 h. </a:t>
            </a:r>
            <a:r>
              <a:rPr lang="en-US" altLang="zh-CN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or each experimental group, three randomly selected TEM images were analyzed. In each image, the total number of mitochondria was counted, and mitochondria displaying characteristic </a:t>
            </a:r>
            <a:r>
              <a:rPr lang="en-US" altLang="zh-CN" sz="1100" kern="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erroptotic</a:t>
            </a:r>
            <a:r>
              <a:rPr lang="en-US" altLang="zh-CN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features were identified. The percentage of mitochondria exhibiting ferroptosis characteristics was calculated per image</a:t>
            </a:r>
            <a:r>
              <a:rPr lang="en-US" altLang="zh-CN" sz="1100" kern="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he data are presented as the mean ± standard errors of the mean.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**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1, ***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01, and ****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001.</a:t>
            </a:r>
            <a:endParaRPr lang="zh-CN" altLang="zh-CN" sz="11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580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34</Words>
  <Application>Microsoft Office PowerPoint</Application>
  <PresentationFormat>A4 纸张(210x297 毫米)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ingchen liao</dc:creator>
  <cp:lastModifiedBy>xingchen liao</cp:lastModifiedBy>
  <cp:revision>24</cp:revision>
  <dcterms:created xsi:type="dcterms:W3CDTF">2026-03-13T14:18:49Z</dcterms:created>
  <dcterms:modified xsi:type="dcterms:W3CDTF">2026-03-19T12:58:50Z</dcterms:modified>
</cp:coreProperties>
</file>